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295" r:id="rId2"/>
    <p:sldId id="294" r:id="rId3"/>
    <p:sldId id="288" r:id="rId4"/>
    <p:sldId id="289" r:id="rId5"/>
    <p:sldId id="292" r:id="rId6"/>
    <p:sldId id="293" r:id="rId7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096" userDrawn="1">
          <p15:clr>
            <a:srgbClr val="A4A3A4"/>
          </p15:clr>
        </p15:guide>
        <p15:guide id="2" pos="1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D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095"/>
    <p:restoredTop sz="92606"/>
  </p:normalViewPr>
  <p:slideViewPr>
    <p:cSldViewPr snapToGrid="0" showGuides="1">
      <p:cViewPr>
        <p:scale>
          <a:sx n="210" d="100"/>
          <a:sy n="210" d="100"/>
        </p:scale>
        <p:origin x="0" y="144"/>
      </p:cViewPr>
      <p:guideLst>
        <p:guide orient="horz" pos="6096"/>
        <p:guide pos="12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45DA71-A0E9-8247-9FA1-496A4356D7F5}" type="datetimeFigureOut">
              <a:rPr lang="en-US" smtClean="0"/>
              <a:t>1/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4F344-4C5F-2241-B9F5-CA0D633D3F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0426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8775834-44CB-71DB-9F69-E73C9DFC4F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0BD99D02-0A8B-C6CA-1C85-EB0B3E1BAD7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D3A584EA-41D1-36ED-E5F2-24142B034BC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FF2F25-E345-485C-47B6-8163D3562D6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D4F344-4C5F-2241-B9F5-CA0D633D3F8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308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D4F344-4C5F-2241-B9F5-CA0D633D3F8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66813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D4F344-4C5F-2241-B9F5-CA0D633D3F8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3704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521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481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306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947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82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182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373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322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513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109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707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997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8B36A4-3419-E644-9852-63F7CD658045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2C2B7D-012B-E149-B9A0-09C911DA0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447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7C5980-F52F-B913-DFE7-DF011DD939B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2">
            <a:extLst>
              <a:ext uri="{FF2B5EF4-FFF2-40B4-BE49-F238E27FC236}">
                <a16:creationId xmlns:a16="http://schemas.microsoft.com/office/drawing/2014/main" id="{2DABB361-C43E-B588-375B-A6C0D4FB36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847" y="209121"/>
            <a:ext cx="5322224" cy="3836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03631" tIns="51816" rIns="103631" bIns="51816" numCol="1" anchor="ctr" anchorCtr="0" compatLnSpc="1">
            <a:prstTxWarp prst="textNoShape">
              <a:avLst/>
            </a:prstTxWarp>
            <a:spAutoFit/>
          </a:bodyPr>
          <a:lstStyle/>
          <a:p>
            <a:pPr defTabSz="103628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813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1A: Alignment of MYO5B</a:t>
            </a:r>
            <a:endParaRPr lang="en-US" altLang="en-US" sz="18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02CD2A9-E32B-B9B9-90CD-3F171447CFC5}"/>
              </a:ext>
            </a:extLst>
          </p:cNvPr>
          <p:cNvSpPr txBox="1"/>
          <p:nvPr/>
        </p:nvSpPr>
        <p:spPr>
          <a:xfrm>
            <a:off x="227847" y="592752"/>
            <a:ext cx="6368356" cy="88177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----------------------------------------------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---------------------------MTYSELYSRYTRVWIPDPDEVWRSAELTKDYKD	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---------------------------MSYSELYTRYTRVWIPDPDEVWRSAELTKDYKE	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MCARGFKSWGRPCVGGDAFHSWKLCFVSESLVFIFQYTRVWIPDPEEVWRSAELTKDYKE	6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---------------------------MSVSELYSQYTRVWIPDPDEVWRSAELTKDYKE	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---------------------------MSVGELYSQCTRVWIPDPDEVWRSAELTKDYKE	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---------------------------MSVGELYSQCTRVWIPDPDEVWRSAELTKDYKE	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</a:t>
            </a:r>
            <a:r>
              <a:rPr lang="en-US" sz="7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92C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-------------------------------------------------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GDESLQLRLEDDTILDYPIDVQNNQVPFLRNPDILVGENDLTALSHLHEPAVLHNLKV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F	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GDKSLQLRLEDDTILEYPVDVQNNQVPFLRNPDILVGENDLTALSHLHEPAVLHNLKV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F	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GDRCLQLRLEDETVREYPINVQSNQLPFLRNPDILVGENDLTALSYLHEPAVLHNLKV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F	12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GEKSLQLRLEDETIQEYPIDVQKNQLPFLRNPDILVGENDLTALSYLHEPAVLHNLKV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F	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GDKSLQLRLEDETILEYPIDVQRNQLPFLRNPDILVGENDLTALSYLHEPAVLHNLKV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F	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GDKSLQLRLEDETILEYPIDVQRNQLPFLRNPDILVGENDLTALSYLHEPAVLHNLKV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F	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----------------------------------------------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LESNHIYTYCGIVLVAINPYEQLPIYGQDVIYAYSGQNMGDMDPHIFAVAEEAYKQMARD	1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LESNHIYTYCGIVLVAINPYEQLPIYGQDVIYAYSGQNMGDMDPHIFAVAEEAYKQMARD	1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LESNHIYTYCGIVLVAINPYEQLPIYGQDVIYAYSGQNMGDMDPHIFAVAEEAYKQMARD	18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LESNHIYTYCGIVLVAINPYEQLPIYGQDVIYAYSGQNMGDMDPHIFAVAEEAYKQMARD	1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LESNHIYTYCGIVLVAINPYEQLPIYGQDVIYTYSGQNMGDMDPHIFAVAEEAYKQMARD	1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LESNHIYTYCGIVLVAINPYEQLPIYGQDVIYAYSGQNMGDMDPHIFAVAEEAYKQMARD	1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</a:t>
            </a:r>
            <a:r>
              <a:rPr lang="en-US" sz="7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-Loop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</a:t>
            </a:r>
            <a:r>
              <a:rPr lang="en-US" sz="7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208A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---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-----------------------------------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EKNQSIIVS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ESGAGK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VSAKYAMRYFATVGGSASDTNIEEKVLASSPIMEAIG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KTTR	2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EKNQSIIVS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ESGAGK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VSAKYAMRYFATVGGSASDTNIEEKVLASSPIMEAIG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KTTR	2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EKNQSIIVS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ESGAGK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VSAKYAMRYFATVGGSASDTNIEEKVLASSPIMEAIG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KTTR	24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EKNQSIIVS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ESGAGK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VSAKYAMRYFATVSGSASDTNIEEKVLASSPIMEAIG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KTTR	2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EKNQSIIVS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ESGAGK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VSAKYAMRYFATVGGSASETNIEEKVLASSPIMEAIG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KTTR	2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EKNQSIIVS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ESGAGK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VSAKYAMRYFATVGGSASETNIEEKVLASSPIMEAIG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KTTR	2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</a:t>
            </a:r>
            <a:r>
              <a:rPr lang="en-US" sz="7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witch 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</a:t>
            </a:r>
            <a:r>
              <a:rPr lang="en-US" sz="7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266R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----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-----------------------------------------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NSSRF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KYIEIGFDKKYHIIGANMRTYLLEKSRVVFQADDERNYHIFYQL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AASLPE	2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NSSRF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KFIEIGFDKKYHIIGANMRTYLLEKSRVVFQADDERNYHIFYQL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AASLPE	2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NSSRF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KYIQIGFDKRYHIIGANMRTYLLEKSRVVFQADDERNYHIFYQL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AASLPE	30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NSSRF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KYIQIGFDKRYHIIGANMRTYLLEKSRVVFQADDERNYHIFYQL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AASLPE	2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NSSRF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KYIQIGFDKRYHIIGANMRTYLLEKSRVVFQADDERNYHIFYQL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AAGLPE	2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</a:t>
            </a:r>
            <a:r>
              <a:rPr lang="en-US" sz="700" kern="100" dirty="0">
                <a:effectLst/>
                <a:highlight>
                  <a:srgbClr val="00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NSSRF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KYIQIGFDKRYHIIGANMRTYLLEKSRVVFQADDERNYHIFYQL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AAAGLPE	2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----------------------------------------------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FKELALTCAEDFFYTAHGGNTTIEGVDDAEDFEKTRQALTLLGVRESHQISIFKIIASIL	3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FKELALTCAEDFFYTAHGGNTTIEGVNDADDFEKTRQALTLLGVRDSHQISIFKIIASIL	3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FKELALTCAEDFFYTSQGGDTCIEGVDDAEDFEKTRQAFTLLGVRESHQISIFKIIASIL	36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FKELALTCAEDFFYASQGGDTSIEGVDDAEDFEKTRQAFTLLGVRESHQISIFKIIASIL	3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FKELALTSAEDFFYTSQGGDTSIEGVDDAEDFEKTRQAFTLLGVKESHQMSIFKIIASIL	3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FKELALTSAEDFFYTSQGGDTSIEGVDDAEDFEKTRQAFTLLGVRESHQISIFKIIASIL	3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----------------------------------------------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HLGSVEIQAERDGDSCSISPQDEHLSNFCRLLGIEHSQMEHWLCHRKLVTTSETYVKTMS	3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HLGSVEIQSERDGDSCSISPQDEHLSNFCSLLGIEHSQMEHWLCHRKLVTTSETYVKTMS	3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HLGSVEIQAERDGESCSISPQDEHLGNFCRLLGVEHSQMEHWLCHRKLVTTSETYVKTMS	42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HLGNVEIQAERDGESCSISPGDEHLSNFCRLLGVEHGQMEHWLCHRKLVTTSETYVKTMS	3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HLGSVAIQAERDGDSCSISPQDVYLSNFCRLLGVEHSQMEHWLCHRKLVTTSETYVKTMS	3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HLGSVEIQAERDGDSCSISPQDEHLSNFCRLLGVEHSQMEHWLCHRKLVTTSETYVKTMS	39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</a:t>
            </a:r>
            <a:r>
              <a:rPr lang="en-US" sz="7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408F                                                         I439A  E443A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-----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---------------------------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--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LQQVVNARNALAKH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AQLFSWIVEHINKALQTSLKQHSFIGVLD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GF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FEINSFEQF	4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LQQVVNARDALAKH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AQLFSWIVEHINKALHTSHKQHSFIGVLD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GF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FEINSFEQF	4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LQQVVNARNALAKH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AQLFSWIVEHINKALHTSLKQHSFIGVLD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GF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FEVNSFEQF	48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LQQVVNARNALAKH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AQLFGWIVEHINKALHTSLKQHSFIGVLD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GF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FEVNSFEQF	4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LQQVINARNALAKH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AQLFGWIVEHINKALHTSLKQHSFIGVLD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GF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FEVNSFEQF	4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LQQVINARNALAKH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AQLFSWIVEHINKALHTSLKQHSFIGVLD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YGF</a:t>
            </a:r>
            <a:r>
              <a:rPr lang="en-US" sz="700" kern="100" dirty="0">
                <a:effectLst/>
                <a:highlight>
                  <a:srgbClr val="00FDFF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FEVNSFEQF	45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----------------------------------------------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CINYANEKLQQQFNSHVFKLEQEEYMKEQIPWTLIDFYDNQPCIDLIEAKLGILDLLDEE	5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CINYANEKLQQQFNSHVFKLEQEEYMKEQIPWTLIDFYDNQPCIDLIEAKLGILDLLDEE	5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CINYANEKLQQQFNSHVFKLEQEEYMKEQIPWTLIDFYDNQPCIDLIEAKLGILDLLDEE	54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CINYANEKLQQQFNSHVFKLEQEEYMKEQIPWTLIDFYDNQPCIDLIEAKLGILDLLDEE	5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CINYANEKLQQQFNSHVFKLEQEEYMKEQIPWTLIDFYDNQPCIDLIEAKLGILDLLDEE	5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CINYANEKLQQQFNSHVFKLEQEEYMKEQIPWTLIDFYDNQPCIDLIEAKLGILDLLDEE	51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55481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2">
            <a:extLst>
              <a:ext uri="{FF2B5EF4-FFF2-40B4-BE49-F238E27FC236}">
                <a16:creationId xmlns:a16="http://schemas.microsoft.com/office/drawing/2014/main" id="{82907FF1-E3AA-BBB1-B487-CEEAA750AD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847" y="209121"/>
            <a:ext cx="5322224" cy="3836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03631" tIns="51816" rIns="103631" bIns="51816" numCol="1" anchor="ctr" anchorCtr="0" compatLnSpc="1">
            <a:prstTxWarp prst="textNoShape">
              <a:avLst/>
            </a:prstTxWarp>
            <a:spAutoFit/>
          </a:bodyPr>
          <a:lstStyle/>
          <a:p>
            <a:pPr defTabSz="103628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813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1B: Alignment of MYO5B</a:t>
            </a:r>
            <a:endParaRPr lang="en-US" altLang="en-US" sz="18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EB3CB87-965F-8A6B-C2EE-9C8B1B60359E}"/>
              </a:ext>
            </a:extLst>
          </p:cNvPr>
          <p:cNvSpPr txBox="1"/>
          <p:nvPr/>
        </p:nvSpPr>
        <p:spPr>
          <a:xfrm>
            <a:off x="0" y="6335856"/>
            <a:ext cx="7316706" cy="11440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1. Alignment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of MYO5B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alignment of seven MYO5B sequences from different species is depicted above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e three predicted mutations are highlighted in blue, the patient mutations are in yellow, and important domains in green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F64341B-4576-950F-F3EA-B0223E509DFF}"/>
              </a:ext>
            </a:extLst>
          </p:cNvPr>
          <p:cNvSpPr txBox="1"/>
          <p:nvPr/>
        </p:nvSpPr>
        <p:spPr>
          <a:xfrm>
            <a:off x="227847" y="592752"/>
            <a:ext cx="6368356" cy="59093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7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G519R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------------------------------------------------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CKVP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DQNWAQKLYERHSNSQHFQKPRMSNTAFIVIHFADKVEYLSDGFLEKNRDTVY	5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CKVP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DQNWAQKLYERHSNSQHFQKPRMSNTAFIVNHFADKVEYLSDGFLEKNRDTVY	5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CKVP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DQNWAQKLYDRHSGSQHFQKPRMSNTAFIVVHFAD------------------	582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CKVP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DQNWAQKLYDRHSGSQHFQKPRMSNTAFIVVHFADKVEYLSDGFLEKNRDTVY	5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CKVP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DQNWAQKLYDRHSSSQHFQKPRMSNTAFIIVHFADKVEYLSDGFLEKNRDTVY	5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CKVP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G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DQNWAQKLYDRHSSSQHFQKPRMSNTAFIIVHFADKVEYLSDGFLEKNRDTVY	57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---------------------------------------------------	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EEQINILKASKFPLVADLFRDDEDSVPATNTAKSRSSSKINVRSSRPLMKAPNKEHKKSV	6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EEQINILKASKFPLVADLFHDDKDSAPATNTAKNRSSSKINVRSSRPLIKVPNKEHKKSV	633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----------KFPLVSDLFHDDKDPAPATTAVGKGSSSKINIRSARPPLKASNKEHKKTV	632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EEQINILKASKFPLVADLFHDDKDSVPAT-A----SSSKISVRSARPPLKTSNKEHKKTV	628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EEQINILKASKFPLVADLFHDDKDPVPAT-TPGKGSSSKISVRSARPPMKVSNKEHKKTV	632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EEQINILKASKFPLVADLFHDDKDPVPAT-TSGKGSSSKISIRSARPPMKASNKEHKKTV	632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               </a:t>
            </a:r>
            <a:r>
              <a:rPr lang="en-US" sz="7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660L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------------------MPLSREMC--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MLKRKIRFDSRRAVQQLRACGVLETIRISA	39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GYQFRTSLNLLMETLNATTPHY-VRCI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EKLPFHFDPKRAVQQLRACGVLETIRISA	692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GYQFRTSLNLLMETLNATTPHY-VRCI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EKLPFHFDPKRAVQQLRACGVLETIRISA	692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GHQFRTSLHLLMETLNATTPHY-VRCI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EKLPFHFDPKRAVQQLRACGVLETIRISA	691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GHQFRTSLHLLMETLNATTPHY-VRCI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EKLPFHFDPKRAVQQLRACGVLETIRISA	687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GHQFRTSLHLLMETLNATTPHY-VRCI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EKLPFHFDPKRAVQQLRACGVLETIRISA	691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GHQFRTSLHLLMETLNATTPHY-VRCIK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NDEKLPFHFDPKRAVQQLRACGVLETIRISA	691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AGYPSRWTYPDFFSRYRVLMTKKDLSV-GDKKQVCKNLLEILIKDPDKFQFGKTKIFFRA	98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AGYPSRWTYHDFFNRYRVLMKKRELANTTDKKNICKSVLESLIKDPDKFQFGRTKIFFRA	752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AGYPSRWTYHDFFNRYRVLMKKRELTN-TDKKNICKSVLESLIKDPDKFQFGRTKIFFRA	751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AGYPSRWAYHDFFNRYRVLVAKRELANT-DKKAVCKAVLQDLLKDPDKFQFGRTKIFFRA	75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AGYPSRWAYHDFFNRYRVLIKKRELANT-DKKAICRSVLESLIKDPDKFQFGRTKIFFRA	746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AGYPSRWAYHDFFNRYRVLVKKRELANT-DKKAICRSVLENLIKDPDKFQFGRTKIFFRA	75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AGYPSRWAYHDFFNRYRVLVKKRELANT-DKKAICRSVLENLIKDPDKFQFGRTKIFFRA	75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GQVAYLEKLRADKFRFACIKIQKTVRGWLQRIRYRKIRKSAITLQRYGRGYLARRYAEML	158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GQVAYLEKLRADKFREATIMIQKTVRGWLQRVKYRRLRAATLTLQRFCRGYLARRLTEHL	812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GQVAYLEKLRADKFREATIMIQKSVRGWLQRVKYRRLRAATLSLQRFCRGYLARRLAEHL	811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GQVAYLEKLRADKFRAATIMIQKTVRGWLQKVKYRRLKGATLTLQRYCRGYLARRLAEHL	81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GQVAYLEKLRADKFRAATIMIQKTVRGWLQKVKYRRLKGATLTLQRYCRGLLARRLAEHL	806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GQVAYLEKLRADKFRTATIMIQKTVRGWLQKVKYHRLKGATLTLQRYCRGHLARRLAEHL	81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GQVAYLEKLRADKFRTATIMIQKTVRGWLQKVKYRRLKGATLTLQRYCRGHLARRLAEHL	81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                                               </a:t>
            </a:r>
            <a:r>
              <a:rPr lang="en-US" sz="7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824C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8M9PIE0|A0A8M9PIE0_ZEBRAFISH  RLTRAAVICQKQY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MVQVRREYLRVRRAVITIQAFTRGMFIRRLYQEFLLHHKAMIIQKT	218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70569|MYO5B_RAT                 RRTRAAIVFQKQY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MLKARRAYCRVRRAAVIIQSYTRGHVCTQKLPPVLTEHKATIIQKY	872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P21271|MYO5B_MOUSE               RRTRAAIVFQKQY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MLKARRAYRRVCRATVIIQSFTRAMFVRRNYRQVLMEHKATIIQKY	871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G1TZ77|G1TZ77_RABIT              RRTRAAVVLQKQY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MRRARLAYQRVRRAAIVIQAFARAMFVRRIYRQVLMEHKATVIQKH	87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5G2R6M1|A0A5G2R6M1_PIG        RRTRAAVVLQKQY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MQRARQAYQMVRRATVVIQAFARGMFVRRIYHQVLREHKATIIQKH	866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sp|Q9ULV0|MYO5B_HUMAN               RRIRAAVVLQKHY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MQRARQAYQRVRRAAVVIQAFTRAMFVRRTYRQVLMEHKATTIQKH	87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tr|A0A1D5R6P3|A0A1D5R6P3_MACAQUE    RRTRAAVVLQKHY</a:t>
            </a:r>
            <a:r>
              <a:rPr lang="en-US" sz="700" kern="100" dirty="0">
                <a:effectLst/>
                <a:highlight>
                  <a:srgbClr val="FFFF00"/>
                </a:highlight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700" kern="100" dirty="0">
                <a:effectLst/>
                <a:latin typeface="Courier New" panose="02070309020205020404" pitchFamily="49" charset="0"/>
                <a:ea typeface="Aptos" panose="020B0004020202020204" pitchFamily="34" charset="0"/>
                <a:cs typeface="Times New Roman" panose="02020603050405020304" pitchFamily="18" charset="0"/>
              </a:rPr>
              <a:t>MQRARQAYQRVRRAAIVIQAFTRAMFVRRTYRQVLMEHKATTIQKH	870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20410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01877EC1-035E-8CB5-3B1B-7617D82D94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7245154"/>
              </p:ext>
            </p:extLst>
          </p:nvPr>
        </p:nvGraphicFramePr>
        <p:xfrm>
          <a:off x="227847" y="592782"/>
          <a:ext cx="6728885" cy="263956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960755">
                  <a:extLst>
                    <a:ext uri="{9D8B030D-6E8A-4147-A177-3AD203B41FA5}">
                      <a16:colId xmlns:a16="http://schemas.microsoft.com/office/drawing/2014/main" val="859533039"/>
                    </a:ext>
                  </a:extLst>
                </a:gridCol>
                <a:gridCol w="960755">
                  <a:extLst>
                    <a:ext uri="{9D8B030D-6E8A-4147-A177-3AD203B41FA5}">
                      <a16:colId xmlns:a16="http://schemas.microsoft.com/office/drawing/2014/main" val="357261389"/>
                    </a:ext>
                  </a:extLst>
                </a:gridCol>
                <a:gridCol w="961475">
                  <a:extLst>
                    <a:ext uri="{9D8B030D-6E8A-4147-A177-3AD203B41FA5}">
                      <a16:colId xmlns:a16="http://schemas.microsoft.com/office/drawing/2014/main" val="4146059128"/>
                    </a:ext>
                  </a:extLst>
                </a:gridCol>
                <a:gridCol w="961475">
                  <a:extLst>
                    <a:ext uri="{9D8B030D-6E8A-4147-A177-3AD203B41FA5}">
                      <a16:colId xmlns:a16="http://schemas.microsoft.com/office/drawing/2014/main" val="4158608022"/>
                    </a:ext>
                  </a:extLst>
                </a:gridCol>
                <a:gridCol w="961475">
                  <a:extLst>
                    <a:ext uri="{9D8B030D-6E8A-4147-A177-3AD203B41FA5}">
                      <a16:colId xmlns:a16="http://schemas.microsoft.com/office/drawing/2014/main" val="276013837"/>
                    </a:ext>
                  </a:extLst>
                </a:gridCol>
                <a:gridCol w="961475">
                  <a:extLst>
                    <a:ext uri="{9D8B030D-6E8A-4147-A177-3AD203B41FA5}">
                      <a16:colId xmlns:a16="http://schemas.microsoft.com/office/drawing/2014/main" val="2676399787"/>
                    </a:ext>
                  </a:extLst>
                </a:gridCol>
                <a:gridCol w="961475">
                  <a:extLst>
                    <a:ext uri="{9D8B030D-6E8A-4147-A177-3AD203B41FA5}">
                      <a16:colId xmlns:a16="http://schemas.microsoft.com/office/drawing/2014/main" val="2110503445"/>
                    </a:ext>
                  </a:extLst>
                </a:gridCol>
              </a:tblGrid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 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F-acti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Motor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6951080"/>
                  </a:ext>
                </a:extLst>
              </a:tr>
              <a:tr h="77270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 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Prediction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Mean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Standard Error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Predictio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Me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Standard Error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3337273787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WT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 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4720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0.0048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5957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48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1106360245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N208A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3869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36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Gaussian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6711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135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1447406133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E443A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Gaussian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4623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23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-0.1436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0.0337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2258994880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I439A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4449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33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3870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0.0095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2707153093"/>
                  </a:ext>
                </a:extLst>
              </a:tr>
            </a:tbl>
          </a:graphicData>
        </a:graphic>
      </p:graphicFrame>
      <p:sp>
        <p:nvSpPr>
          <p:cNvPr id="11" name="Rectangle 2">
            <a:extLst>
              <a:ext uri="{FF2B5EF4-FFF2-40B4-BE49-F238E27FC236}">
                <a16:creationId xmlns:a16="http://schemas.microsoft.com/office/drawing/2014/main" id="{BA262354-F490-0749-3B0F-DF160F2928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847" y="209121"/>
            <a:ext cx="6477412" cy="3836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03631" tIns="51816" rIns="103631" bIns="51816" numCol="1" anchor="ctr" anchorCtr="0" compatLnSpc="1">
            <a:prstTxWarp prst="textNoShape">
              <a:avLst/>
            </a:prstTxWarp>
            <a:spAutoFit/>
          </a:bodyPr>
          <a:lstStyle/>
          <a:p>
            <a:pPr defTabSz="103628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813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Table 1: Predicted Mutants Best-Fit Model </a:t>
            </a:r>
            <a:endParaRPr lang="en-US" altLang="en-US" sz="18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9D2DF23-ED81-C769-A79C-9BB2600EA11F}"/>
              </a:ext>
            </a:extLst>
          </p:cNvPr>
          <p:cNvSpPr txBox="1"/>
          <p:nvPr/>
        </p:nvSpPr>
        <p:spPr>
          <a:xfrm>
            <a:off x="227847" y="3216896"/>
            <a:ext cx="7316706" cy="11440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Table 1. Outputs from the prediction of the best fit model of predicted mutants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l predicted mutants, both the F-actin and MYO5B-MD line scans, were best fit by a Gaussian curve. The Means and the standard error are reported as well. </a:t>
            </a:r>
          </a:p>
        </p:txBody>
      </p:sp>
    </p:spTree>
    <p:extLst>
      <p:ext uri="{BB962C8B-B14F-4D97-AF65-F5344CB8AC3E}">
        <p14:creationId xmlns:p14="http://schemas.microsoft.com/office/powerpoint/2010/main" val="33071822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E3B18C9-4AC0-80A3-A3AA-C9E787F590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8034018"/>
              </p:ext>
            </p:extLst>
          </p:nvPr>
        </p:nvGraphicFramePr>
        <p:xfrm>
          <a:off x="146202" y="514996"/>
          <a:ext cx="7209998" cy="337718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029449">
                  <a:extLst>
                    <a:ext uri="{9D8B030D-6E8A-4147-A177-3AD203B41FA5}">
                      <a16:colId xmlns:a16="http://schemas.microsoft.com/office/drawing/2014/main" val="1995208959"/>
                    </a:ext>
                  </a:extLst>
                </a:gridCol>
                <a:gridCol w="1029449">
                  <a:extLst>
                    <a:ext uri="{9D8B030D-6E8A-4147-A177-3AD203B41FA5}">
                      <a16:colId xmlns:a16="http://schemas.microsoft.com/office/drawing/2014/main" val="1136425737"/>
                    </a:ext>
                  </a:extLst>
                </a:gridCol>
                <a:gridCol w="1030220">
                  <a:extLst>
                    <a:ext uri="{9D8B030D-6E8A-4147-A177-3AD203B41FA5}">
                      <a16:colId xmlns:a16="http://schemas.microsoft.com/office/drawing/2014/main" val="3523634482"/>
                    </a:ext>
                  </a:extLst>
                </a:gridCol>
                <a:gridCol w="1030220">
                  <a:extLst>
                    <a:ext uri="{9D8B030D-6E8A-4147-A177-3AD203B41FA5}">
                      <a16:colId xmlns:a16="http://schemas.microsoft.com/office/drawing/2014/main" val="3575277120"/>
                    </a:ext>
                  </a:extLst>
                </a:gridCol>
                <a:gridCol w="1030220">
                  <a:extLst>
                    <a:ext uri="{9D8B030D-6E8A-4147-A177-3AD203B41FA5}">
                      <a16:colId xmlns:a16="http://schemas.microsoft.com/office/drawing/2014/main" val="3856792261"/>
                    </a:ext>
                  </a:extLst>
                </a:gridCol>
                <a:gridCol w="1030220">
                  <a:extLst>
                    <a:ext uri="{9D8B030D-6E8A-4147-A177-3AD203B41FA5}">
                      <a16:colId xmlns:a16="http://schemas.microsoft.com/office/drawing/2014/main" val="2282275091"/>
                    </a:ext>
                  </a:extLst>
                </a:gridCol>
                <a:gridCol w="1030220">
                  <a:extLst>
                    <a:ext uri="{9D8B030D-6E8A-4147-A177-3AD203B41FA5}">
                      <a16:colId xmlns:a16="http://schemas.microsoft.com/office/drawing/2014/main" val="2698469285"/>
                    </a:ext>
                  </a:extLst>
                </a:gridCol>
              </a:tblGrid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 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F-actin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Motor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8634435"/>
                  </a:ext>
                </a:extLst>
              </a:tr>
              <a:tr h="77270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 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Predictio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Mean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Standard Error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Predictio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Me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Standard Error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1634126420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P660L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Gaussian 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4819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0.0023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1102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92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2678104047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519R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Gaussian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4914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20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Gaussian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0.3970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109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2065624336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I408F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5059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25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-0.1266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0.0272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4235232670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C266R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4728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24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3323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0.0051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2245528893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R824C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5120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25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2597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0.0096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1967264202"/>
                  </a:ext>
                </a:extLst>
              </a:tr>
              <a:tr h="3581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R92C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4592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0035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Gaus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</a:rPr>
                        <a:t>0.5417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</a:rPr>
                        <a:t>0.0085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7724" marR="77724" marT="0" marB="0" anchor="ctr"/>
                </a:tc>
                <a:extLst>
                  <a:ext uri="{0D108BD9-81ED-4DB2-BD59-A6C34878D82A}">
                    <a16:rowId xmlns:a16="http://schemas.microsoft.com/office/drawing/2014/main" val="3527994293"/>
                  </a:ext>
                </a:extLst>
              </a:tr>
            </a:tbl>
          </a:graphicData>
        </a:graphic>
      </p:graphicFrame>
      <p:sp>
        <p:nvSpPr>
          <p:cNvPr id="2" name="Rectangle 2">
            <a:extLst>
              <a:ext uri="{FF2B5EF4-FFF2-40B4-BE49-F238E27FC236}">
                <a16:creationId xmlns:a16="http://schemas.microsoft.com/office/drawing/2014/main" id="{6F89E012-6F4C-B97F-234F-BD2109167C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203" y="131336"/>
            <a:ext cx="7626766" cy="3836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03631" tIns="51816" rIns="103631" bIns="51816" numCol="1" anchor="ctr" anchorCtr="0" compatLnSpc="1">
            <a:prstTxWarp prst="textNoShape">
              <a:avLst/>
            </a:prstTxWarp>
            <a:spAutoFit/>
          </a:bodyPr>
          <a:lstStyle/>
          <a:p>
            <a:pPr defTabSz="103628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813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Table 2: Predicted Best-Fit Model for Patient Mutants</a:t>
            </a:r>
            <a:endParaRPr lang="en-US" altLang="en-US" sz="18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161D117-A7C5-B6C7-101D-EEA6CADD03B1}"/>
              </a:ext>
            </a:extLst>
          </p:cNvPr>
          <p:cNvSpPr txBox="1"/>
          <p:nvPr/>
        </p:nvSpPr>
        <p:spPr>
          <a:xfrm>
            <a:off x="146201" y="3857923"/>
            <a:ext cx="7209998" cy="11440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Table 2. Outputs from the prediction of the best fit model of patient mutants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l patient mutants, both the F-actin and MYO5B-MD line scans, were best fit by a Gaussian curve. The Means and the standard error are reported as well. </a:t>
            </a:r>
          </a:p>
        </p:txBody>
      </p:sp>
    </p:spTree>
    <p:extLst>
      <p:ext uri="{BB962C8B-B14F-4D97-AF65-F5344CB8AC3E}">
        <p14:creationId xmlns:p14="http://schemas.microsoft.com/office/powerpoint/2010/main" val="26308269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4EDDE35-241C-963A-BBC4-AEA1FEE83D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5818373"/>
              </p:ext>
            </p:extLst>
          </p:nvPr>
        </p:nvGraphicFramePr>
        <p:xfrm>
          <a:off x="218787" y="562036"/>
          <a:ext cx="7074642" cy="314040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2063607">
                  <a:extLst>
                    <a:ext uri="{9D8B030D-6E8A-4147-A177-3AD203B41FA5}">
                      <a16:colId xmlns:a16="http://schemas.microsoft.com/office/drawing/2014/main" val="1149704534"/>
                    </a:ext>
                  </a:extLst>
                </a:gridCol>
                <a:gridCol w="5011035">
                  <a:extLst>
                    <a:ext uri="{9D8B030D-6E8A-4147-A177-3AD203B41FA5}">
                      <a16:colId xmlns:a16="http://schemas.microsoft.com/office/drawing/2014/main" val="1164456046"/>
                    </a:ext>
                  </a:extLst>
                </a:gridCol>
              </a:tblGrid>
              <a:tr h="72144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Name of Prim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Sequence 5'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3807671235"/>
                  </a:ext>
                </a:extLst>
              </a:tr>
              <a:tr h="2404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N208A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ATCATGGAGGCCATTGGAGCTGCCAAGACCACC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1643638541"/>
                  </a:ext>
                </a:extLst>
              </a:tr>
              <a:tr h="2404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439A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CTTCATCGGGGTCCTGGACGCCTATGGGTTTGAGACAT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2625362141"/>
                  </a:ext>
                </a:extLst>
              </a:tr>
              <a:tr h="2404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E443A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CTGGACATCTATGGGTTTGCGACATTTGAGGTAAACA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2994137884"/>
                  </a:ext>
                </a:extLst>
              </a:tr>
              <a:tr h="2404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660L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GTCCGCTGCATCAAGCTCAACGATGAGAAGCT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2862464238"/>
                  </a:ext>
                </a:extLst>
              </a:tr>
              <a:tr h="2404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G519R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GAATGTAAGGTCCCCAAAAGAACTGACCAGAAC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1319621397"/>
                  </a:ext>
                </a:extLst>
              </a:tr>
              <a:tr h="2404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C266R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ATCTTTTACCAGCTCCGTGCTGCTGCCGG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498357373"/>
                  </a:ext>
                </a:extLst>
              </a:tr>
              <a:tr h="2404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408F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CCTGGCGAAGCACTTCTATGCCCAGTT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996214327"/>
                  </a:ext>
                </a:extLst>
              </a:tr>
              <a:tr h="2404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R824C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GTGCTCCAGAAACATTACGCCATGCAGAGGGCC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2001190267"/>
                  </a:ext>
                </a:extLst>
              </a:tr>
              <a:tr h="2404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R92C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TTGCATAATTTGAAGGTCTGTTTCCTGGAGTCCAAC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3604558338"/>
                  </a:ext>
                </a:extLst>
              </a:tr>
              <a:tr h="25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H138P_Myo5b_H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GAGACATGGACCCCCCCATCTTTGCTGTGG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610" marR="10610" marT="10610" marB="0" anchor="ctr"/>
                </a:tc>
                <a:extLst>
                  <a:ext uri="{0D108BD9-81ED-4DB2-BD59-A6C34878D82A}">
                    <a16:rowId xmlns:a16="http://schemas.microsoft.com/office/drawing/2014/main" val="2398188653"/>
                  </a:ext>
                </a:extLst>
              </a:tr>
            </a:tbl>
          </a:graphicData>
        </a:graphic>
      </p:graphicFrame>
      <p:sp>
        <p:nvSpPr>
          <p:cNvPr id="6" name="Rectangle 2">
            <a:extLst>
              <a:ext uri="{FF2B5EF4-FFF2-40B4-BE49-F238E27FC236}">
                <a16:creationId xmlns:a16="http://schemas.microsoft.com/office/drawing/2014/main" id="{1B4F2DB7-09DA-42CE-4BA0-01183C7153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8787" y="178405"/>
            <a:ext cx="4355036" cy="3836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03631" tIns="51816" rIns="103631" bIns="51816" numCol="1" anchor="ctr" anchorCtr="0" compatLnSpc="1">
            <a:prstTxWarp prst="textNoShape">
              <a:avLst/>
            </a:prstTxWarp>
            <a:spAutoFit/>
          </a:bodyPr>
          <a:lstStyle/>
          <a:p>
            <a:pPr defTabSz="103628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813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Table 3: List of Primers</a:t>
            </a:r>
            <a:endParaRPr lang="en-US" altLang="en-US" sz="18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4AAE8B8-3B10-D705-68BC-93B0F57C1D64}"/>
              </a:ext>
            </a:extLst>
          </p:cNvPr>
          <p:cNvSpPr txBox="1"/>
          <p:nvPr/>
        </p:nvSpPr>
        <p:spPr>
          <a:xfrm>
            <a:off x="218787" y="3702442"/>
            <a:ext cx="7074642" cy="11440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Table 3. List of all primers to create each of the MYO5B-MD constructs used in this study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utagenesis primers used to create each of the MYO5B-MD-3xCitrine constructs used in this study. Mutagenesis was done on the WT MYO5B-MD-3xCitrine construct.  </a:t>
            </a:r>
          </a:p>
        </p:txBody>
      </p:sp>
    </p:spTree>
    <p:extLst>
      <p:ext uri="{BB962C8B-B14F-4D97-AF65-F5344CB8AC3E}">
        <p14:creationId xmlns:p14="http://schemas.microsoft.com/office/powerpoint/2010/main" val="10098565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3367607F-F9F9-9116-6958-2D797C5F3E4C}"/>
              </a:ext>
            </a:extLst>
          </p:cNvPr>
          <p:cNvSpPr txBox="1"/>
          <p:nvPr/>
        </p:nvSpPr>
        <p:spPr>
          <a:xfrm>
            <a:off x="0" y="281903"/>
            <a:ext cx="8362573" cy="370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1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Western Blot of MYO5B-MD Constructs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60B6D7E3-49D8-5CBE-A92E-3349338998E2}"/>
              </a:ext>
            </a:extLst>
          </p:cNvPr>
          <p:cNvGrpSpPr/>
          <p:nvPr/>
        </p:nvGrpSpPr>
        <p:grpSpPr>
          <a:xfrm>
            <a:off x="149833" y="652774"/>
            <a:ext cx="6839433" cy="4231649"/>
            <a:chOff x="-65316" y="668626"/>
            <a:chExt cx="7257518" cy="4507530"/>
          </a:xfrm>
        </p:grpSpPr>
        <p:pic>
          <p:nvPicPr>
            <p:cNvPr id="4" name="Picture 3" descr="A close-up of a test&#10;&#10;Description automatically generated">
              <a:extLst>
                <a:ext uri="{FF2B5EF4-FFF2-40B4-BE49-F238E27FC236}">
                  <a16:creationId xmlns:a16="http://schemas.microsoft.com/office/drawing/2014/main" id="{880143C8-2F7F-16B0-577A-471DDC5D3B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5293" t="19722" r="29083" b="46491"/>
            <a:stretch/>
          </p:blipFill>
          <p:spPr>
            <a:xfrm>
              <a:off x="539847" y="1010770"/>
              <a:ext cx="6652355" cy="416538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F063802-BF8A-AAC2-05FE-DBB9AB1F10E2}"/>
                </a:ext>
              </a:extLst>
            </p:cNvPr>
            <p:cNvSpPr txBox="1"/>
            <p:nvPr/>
          </p:nvSpPr>
          <p:spPr>
            <a:xfrm rot="18368185">
              <a:off x="1260303" y="872271"/>
              <a:ext cx="684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ontrol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7287E6D-CF57-7F92-476D-957311B7C9BC}"/>
                </a:ext>
              </a:extLst>
            </p:cNvPr>
            <p:cNvSpPr txBox="1"/>
            <p:nvPr/>
          </p:nvSpPr>
          <p:spPr>
            <a:xfrm rot="18368185">
              <a:off x="1840180" y="1045670"/>
              <a:ext cx="3985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WT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57E52F6-3109-62BF-7B97-53515322E88E}"/>
                </a:ext>
              </a:extLst>
            </p:cNvPr>
            <p:cNvSpPr txBox="1"/>
            <p:nvPr/>
          </p:nvSpPr>
          <p:spPr>
            <a:xfrm rot="18368185">
              <a:off x="2308291" y="904014"/>
              <a:ext cx="6303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N208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281A510-67FB-74A2-0F85-BC6DF9CE1A6A}"/>
                </a:ext>
              </a:extLst>
            </p:cNvPr>
            <p:cNvSpPr txBox="1"/>
            <p:nvPr/>
          </p:nvSpPr>
          <p:spPr>
            <a:xfrm rot="18368185">
              <a:off x="2887960" y="918255"/>
              <a:ext cx="6062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E443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3AA97C8-B795-AAEA-00EF-5EDAFF0A520A}"/>
                </a:ext>
              </a:extLst>
            </p:cNvPr>
            <p:cNvSpPr txBox="1"/>
            <p:nvPr/>
          </p:nvSpPr>
          <p:spPr>
            <a:xfrm rot="18368185">
              <a:off x="3396406" y="946089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I439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E84971C-AD95-3AB3-DEC1-49C6DB1A5041}"/>
                </a:ext>
              </a:extLst>
            </p:cNvPr>
            <p:cNvSpPr txBox="1"/>
            <p:nvPr/>
          </p:nvSpPr>
          <p:spPr>
            <a:xfrm rot="18368185">
              <a:off x="3947221" y="924728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660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307DFA9-0A85-D915-D7E0-9A62EF3AB1CA}"/>
                </a:ext>
              </a:extLst>
            </p:cNvPr>
            <p:cNvSpPr txBox="1"/>
            <p:nvPr/>
          </p:nvSpPr>
          <p:spPr>
            <a:xfrm rot="18368185">
              <a:off x="4431122" y="902720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G519R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CF6C527-0DCD-5D94-1EBE-5FE2CF33BA06}"/>
                </a:ext>
              </a:extLst>
            </p:cNvPr>
            <p:cNvSpPr txBox="1"/>
            <p:nvPr/>
          </p:nvSpPr>
          <p:spPr>
            <a:xfrm rot="18368185">
              <a:off x="5039646" y="951915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I408F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B4DF295-9725-9577-C690-B9690B960FCC}"/>
                </a:ext>
              </a:extLst>
            </p:cNvPr>
            <p:cNvSpPr txBox="1"/>
            <p:nvPr/>
          </p:nvSpPr>
          <p:spPr>
            <a:xfrm rot="18368185">
              <a:off x="5568021" y="904014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266R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A6DB6D9-0D3D-D009-4DEF-A8FC9F491901}"/>
                </a:ext>
              </a:extLst>
            </p:cNvPr>
            <p:cNvSpPr txBox="1"/>
            <p:nvPr/>
          </p:nvSpPr>
          <p:spPr>
            <a:xfrm rot="18368185">
              <a:off x="6086681" y="904014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R824C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CA54184-D72D-34CD-9495-297D88E1F4DA}"/>
                </a:ext>
              </a:extLst>
            </p:cNvPr>
            <p:cNvSpPr txBox="1"/>
            <p:nvPr/>
          </p:nvSpPr>
          <p:spPr>
            <a:xfrm rot="18368185">
              <a:off x="6646220" y="953857"/>
              <a:ext cx="5469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R92C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E92D634-5FDF-D084-DA74-7247F188BBC0}"/>
                </a:ext>
              </a:extLst>
            </p:cNvPr>
            <p:cNvSpPr txBox="1"/>
            <p:nvPr/>
          </p:nvSpPr>
          <p:spPr>
            <a:xfrm>
              <a:off x="483876" y="783771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⍺-</a:t>
              </a:r>
              <a:r>
                <a:rPr lang="en-US" sz="1200" dirty="0" err="1"/>
                <a:t>eGFP</a:t>
              </a:r>
              <a:endParaRPr lang="en-US" sz="12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697F9EC-AB0F-F024-97FD-86D49B41FEC1}"/>
                </a:ext>
              </a:extLst>
            </p:cNvPr>
            <p:cNvSpPr txBox="1"/>
            <p:nvPr/>
          </p:nvSpPr>
          <p:spPr>
            <a:xfrm>
              <a:off x="-65316" y="1392684"/>
              <a:ext cx="6926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50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E763BC2-4BA1-1261-FB51-DBCA6B3E59C1}"/>
                </a:ext>
              </a:extLst>
            </p:cNvPr>
            <p:cNvSpPr txBox="1"/>
            <p:nvPr/>
          </p:nvSpPr>
          <p:spPr>
            <a:xfrm>
              <a:off x="-65316" y="1946666"/>
              <a:ext cx="6926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50kD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5094E3F-FB0B-076F-2EEC-C80DC6C8BA91}"/>
                </a:ext>
              </a:extLst>
            </p:cNvPr>
            <p:cNvSpPr txBox="1"/>
            <p:nvPr/>
          </p:nvSpPr>
          <p:spPr>
            <a:xfrm>
              <a:off x="-65316" y="2596924"/>
              <a:ext cx="6926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00kD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5291E6E-D5E5-B27A-BD8E-A99AB4630216}"/>
                </a:ext>
              </a:extLst>
            </p:cNvPr>
            <p:cNvSpPr txBox="1"/>
            <p:nvPr/>
          </p:nvSpPr>
          <p:spPr>
            <a:xfrm>
              <a:off x="16438" y="3093463"/>
              <a:ext cx="6109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75kDa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81710D0-43E4-8A62-F191-FF3C787C1C60}"/>
                </a:ext>
              </a:extLst>
            </p:cNvPr>
            <p:cNvSpPr txBox="1"/>
            <p:nvPr/>
          </p:nvSpPr>
          <p:spPr>
            <a:xfrm>
              <a:off x="16438" y="4541118"/>
              <a:ext cx="6109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kDa</a:t>
              </a: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5B2B6FFA-1A29-51E0-B9C9-7F863EFF8050}"/>
              </a:ext>
            </a:extLst>
          </p:cNvPr>
          <p:cNvSpPr txBox="1"/>
          <p:nvPr/>
        </p:nvSpPr>
        <p:spPr>
          <a:xfrm>
            <a:off x="55199" y="7965075"/>
            <a:ext cx="7401506" cy="15134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: Expression of all 3x-Citrine-MYO5B-MD constructs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of all 3x-Citrine-MYO5B-MD constructs. MYO5B-MD constructs were detected with an anti-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GFP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tibody. The red dot denotes the MYO5B-MD construct band at 200kDa. B) A western blot probed with a β-actin antibody to use as a loading control. The red dot indicates the band at 42kDa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C661C12-1D81-D8DE-68FE-93C18C949E8F}"/>
              </a:ext>
            </a:extLst>
          </p:cNvPr>
          <p:cNvSpPr txBox="1"/>
          <p:nvPr/>
        </p:nvSpPr>
        <p:spPr>
          <a:xfrm>
            <a:off x="-35101" y="73472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69C8A820-6465-A393-9DBB-5147DCF93D19}"/>
              </a:ext>
            </a:extLst>
          </p:cNvPr>
          <p:cNvGrpSpPr/>
          <p:nvPr/>
        </p:nvGrpSpPr>
        <p:grpSpPr>
          <a:xfrm>
            <a:off x="256239" y="5248677"/>
            <a:ext cx="6736156" cy="2679596"/>
            <a:chOff x="-741988" y="4841865"/>
            <a:chExt cx="9056691" cy="3602689"/>
          </a:xfrm>
        </p:grpSpPr>
        <p:pic>
          <p:nvPicPr>
            <p:cNvPr id="3" name="Picture 2" descr="A paper with a test result&#10;&#10;Description automatically generated with medium confidence">
              <a:extLst>
                <a:ext uri="{FF2B5EF4-FFF2-40B4-BE49-F238E27FC236}">
                  <a16:creationId xmlns:a16="http://schemas.microsoft.com/office/drawing/2014/main" id="{0EC5AC31-A57B-AEC9-389B-83908EC8DEF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4437" t="51112" r="29467" b="28375"/>
            <a:stretch/>
          </p:blipFill>
          <p:spPr>
            <a:xfrm>
              <a:off x="-135418" y="5266638"/>
              <a:ext cx="8445913" cy="3177916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1D5745D-E92F-14D5-9AC7-AA3C0B8C251A}"/>
                </a:ext>
              </a:extLst>
            </p:cNvPr>
            <p:cNvSpPr txBox="1"/>
            <p:nvPr/>
          </p:nvSpPr>
          <p:spPr>
            <a:xfrm rot="18368185">
              <a:off x="679044" y="5122320"/>
              <a:ext cx="933331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ontrol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CCEFE90-4C0C-27AE-1E58-E6337DA0A08E}"/>
                </a:ext>
              </a:extLst>
            </p:cNvPr>
            <p:cNvSpPr txBox="1"/>
            <p:nvPr/>
          </p:nvSpPr>
          <p:spPr>
            <a:xfrm rot="18368185">
              <a:off x="1517316" y="5148650"/>
              <a:ext cx="868124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WT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B262BA0-57A8-E707-4436-C89E41DA53EC}"/>
                </a:ext>
              </a:extLst>
            </p:cNvPr>
            <p:cNvSpPr txBox="1"/>
            <p:nvPr/>
          </p:nvSpPr>
          <p:spPr>
            <a:xfrm rot="18368185">
              <a:off x="2114908" y="5154063"/>
              <a:ext cx="854720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N208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124B4B9-E944-6612-037C-394CC7F35C3F}"/>
                </a:ext>
              </a:extLst>
            </p:cNvPr>
            <p:cNvSpPr txBox="1"/>
            <p:nvPr/>
          </p:nvSpPr>
          <p:spPr>
            <a:xfrm rot="18368185">
              <a:off x="2830821" y="5168304"/>
              <a:ext cx="819454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E443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19058DD-64DD-9D8B-91AC-21CC0E6E7E1D}"/>
                </a:ext>
              </a:extLst>
            </p:cNvPr>
            <p:cNvSpPr txBox="1"/>
            <p:nvPr/>
          </p:nvSpPr>
          <p:spPr>
            <a:xfrm rot="18368185">
              <a:off x="3563561" y="5196138"/>
              <a:ext cx="750526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I439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D88D2DB-47F6-05D7-BF4E-837907564FB5}"/>
                </a:ext>
              </a:extLst>
            </p:cNvPr>
            <p:cNvSpPr txBox="1"/>
            <p:nvPr/>
          </p:nvSpPr>
          <p:spPr>
            <a:xfrm rot="18368185">
              <a:off x="4235389" y="5174776"/>
              <a:ext cx="803425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660L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655E905-183C-B311-9386-F2DBDAAE4BE2}"/>
                </a:ext>
              </a:extLst>
            </p:cNvPr>
            <p:cNvSpPr txBox="1"/>
            <p:nvPr/>
          </p:nvSpPr>
          <p:spPr>
            <a:xfrm rot="18368185">
              <a:off x="4906417" y="5152768"/>
              <a:ext cx="857927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G519R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EFF1BE9-87F1-680C-327C-BCCD5D82833F}"/>
                </a:ext>
              </a:extLst>
            </p:cNvPr>
            <p:cNvSpPr txBox="1"/>
            <p:nvPr/>
          </p:nvSpPr>
          <p:spPr>
            <a:xfrm rot="18368185">
              <a:off x="5665607" y="5201963"/>
              <a:ext cx="736099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I408F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1BFEA6E-0983-6DD4-3442-4CD88B5EE8E8}"/>
                </a:ext>
              </a:extLst>
            </p:cNvPr>
            <p:cNvSpPr txBox="1"/>
            <p:nvPr/>
          </p:nvSpPr>
          <p:spPr>
            <a:xfrm rot="18368185">
              <a:off x="6304576" y="5154063"/>
              <a:ext cx="854720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266R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38617BF-56A5-2694-A8FA-76EB435F1AC9}"/>
                </a:ext>
              </a:extLst>
            </p:cNvPr>
            <p:cNvSpPr txBox="1"/>
            <p:nvPr/>
          </p:nvSpPr>
          <p:spPr>
            <a:xfrm rot="18368185">
              <a:off x="7002852" y="5154063"/>
              <a:ext cx="854720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R824C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9D3AC45-1CE8-A21F-0634-C097563B89D2}"/>
                </a:ext>
              </a:extLst>
            </p:cNvPr>
            <p:cNvSpPr txBox="1"/>
            <p:nvPr/>
          </p:nvSpPr>
          <p:spPr>
            <a:xfrm rot="18368185">
              <a:off x="7762847" y="5203906"/>
              <a:ext cx="731290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R92C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7F7EF67-981B-418A-A490-56EB5CB9F109}"/>
                </a:ext>
              </a:extLst>
            </p:cNvPr>
            <p:cNvSpPr txBox="1"/>
            <p:nvPr/>
          </p:nvSpPr>
          <p:spPr>
            <a:xfrm>
              <a:off x="-728254" y="5609652"/>
              <a:ext cx="825611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50kD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4A65A1E-8060-9A0B-BF62-DB0A2CA8946C}"/>
                </a:ext>
              </a:extLst>
            </p:cNvPr>
            <p:cNvSpPr txBox="1"/>
            <p:nvPr/>
          </p:nvSpPr>
          <p:spPr>
            <a:xfrm>
              <a:off x="-741988" y="6657771"/>
              <a:ext cx="825611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7kDa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60C847C-5E01-7DBD-A1F7-08E4A3469D26}"/>
                </a:ext>
              </a:extLst>
            </p:cNvPr>
            <p:cNvSpPr txBox="1"/>
            <p:nvPr/>
          </p:nvSpPr>
          <p:spPr>
            <a:xfrm>
              <a:off x="-728254" y="7470996"/>
              <a:ext cx="825611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5kDa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096FC33-77EC-B201-709F-24834DD55DF0}"/>
                </a:ext>
              </a:extLst>
            </p:cNvPr>
            <p:cNvSpPr txBox="1"/>
            <p:nvPr/>
          </p:nvSpPr>
          <p:spPr>
            <a:xfrm>
              <a:off x="-162252" y="4989370"/>
              <a:ext cx="917239" cy="372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β-Actin</a:t>
              </a: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3FAB58C9-2DFD-AB45-62DB-83549146D92A}"/>
              </a:ext>
            </a:extLst>
          </p:cNvPr>
          <p:cNvSpPr txBox="1"/>
          <p:nvPr/>
        </p:nvSpPr>
        <p:spPr>
          <a:xfrm>
            <a:off x="-26821" y="517177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5E4B685D-4904-EB74-2D56-167074FADB92}"/>
              </a:ext>
            </a:extLst>
          </p:cNvPr>
          <p:cNvSpPr/>
          <p:nvPr/>
        </p:nvSpPr>
        <p:spPr>
          <a:xfrm>
            <a:off x="1787525" y="1592561"/>
            <a:ext cx="96539" cy="96539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4BEE955D-CCB9-72E1-523E-1802A2190A06}"/>
              </a:ext>
            </a:extLst>
          </p:cNvPr>
          <p:cNvSpPr/>
          <p:nvPr/>
        </p:nvSpPr>
        <p:spPr>
          <a:xfrm>
            <a:off x="1211059" y="6441004"/>
            <a:ext cx="96539" cy="96539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39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</TotalTime>
  <Words>1601</Words>
  <Application>Microsoft Macintosh PowerPoint</Application>
  <PresentationFormat>Custom</PresentationFormat>
  <Paragraphs>293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ptos</vt:lpstr>
      <vt:lpstr>Aptos Display</vt:lpstr>
      <vt:lpstr>Arial</vt:lpstr>
      <vt:lpstr>Calibri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owman, Deanna M</dc:creator>
  <cp:lastModifiedBy>Bowman, Deanna M</cp:lastModifiedBy>
  <cp:revision>11</cp:revision>
  <dcterms:created xsi:type="dcterms:W3CDTF">2024-09-03T15:02:03Z</dcterms:created>
  <dcterms:modified xsi:type="dcterms:W3CDTF">2025-01-07T22:59:33Z</dcterms:modified>
</cp:coreProperties>
</file>